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6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236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upplementary Figure S1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78262" y="304800"/>
            <a:ext cx="6868034" cy="65532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0" y="0"/>
            <a:ext cx="2428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 smtClean="0">
                <a:latin typeface="Times New Roman" pitchFamily="18" charset="0"/>
                <a:cs typeface="Times New Roman" pitchFamily="18" charset="0"/>
              </a:rPr>
              <a:t> Figure S1</a:t>
            </a:r>
            <a:endParaRPr lang="es-E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5309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 smtClean="0">
                <a:latin typeface="Times New Roman" pitchFamily="18" charset="0"/>
                <a:cs typeface="Times New Roman" pitchFamily="18" charset="0"/>
              </a:rPr>
              <a:t> Figure S10</a:t>
            </a:r>
            <a:endParaRPr lang="es-E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2" descr="SCC00.tif"/>
          <p:cNvPicPr>
            <a:picLocks noChangeAspect="1"/>
          </p:cNvPicPr>
          <p:nvPr/>
        </p:nvPicPr>
        <p:blipFill>
          <a:blip r:embed="rId2" cstate="print"/>
          <a:srcRect b="51077"/>
          <a:stretch>
            <a:fillRect/>
          </a:stretch>
        </p:blipFill>
        <p:spPr>
          <a:xfrm>
            <a:off x="-12700" y="608688"/>
            <a:ext cx="9144000" cy="3353712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upplementary Figure S2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714413"/>
            <a:ext cx="9144000" cy="248598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2428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 smtClean="0">
                <a:latin typeface="Times New Roman" pitchFamily="18" charset="0"/>
                <a:cs typeface="Times New Roman" pitchFamily="18" charset="0"/>
              </a:rPr>
              <a:t> Figure S2</a:t>
            </a:r>
            <a:endParaRPr lang="es-E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upplementary Figure S3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649514"/>
            <a:ext cx="9144000" cy="460828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2428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 smtClean="0">
                <a:latin typeface="Times New Roman" pitchFamily="18" charset="0"/>
                <a:cs typeface="Times New Roman" pitchFamily="18" charset="0"/>
              </a:rPr>
              <a:t> Figure S3</a:t>
            </a:r>
            <a:endParaRPr lang="es-E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upplementary Figure S4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649514"/>
            <a:ext cx="9144000" cy="460828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2428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 smtClean="0">
                <a:latin typeface="Times New Roman" pitchFamily="18" charset="0"/>
                <a:cs typeface="Times New Roman" pitchFamily="18" charset="0"/>
              </a:rPr>
              <a:t> Figure S4</a:t>
            </a:r>
            <a:endParaRPr lang="es-E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pplementary Figure S5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679938"/>
            <a:ext cx="9144000" cy="404446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2428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 smtClean="0">
                <a:latin typeface="Times New Roman" pitchFamily="18" charset="0"/>
                <a:cs typeface="Times New Roman" pitchFamily="18" charset="0"/>
              </a:rPr>
              <a:t> Figure S5</a:t>
            </a:r>
            <a:endParaRPr lang="es-E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pplementary Figure S6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679938"/>
            <a:ext cx="9144000" cy="404446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2428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 smtClean="0">
                <a:latin typeface="Times New Roman" pitchFamily="18" charset="0"/>
                <a:cs typeface="Times New Roman" pitchFamily="18" charset="0"/>
              </a:rPr>
              <a:t> Figure S6</a:t>
            </a:r>
            <a:endParaRPr lang="es-E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pplementary Figure S7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696686"/>
            <a:ext cx="9144000" cy="478971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2428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 smtClean="0">
                <a:latin typeface="Times New Roman" pitchFamily="18" charset="0"/>
                <a:cs typeface="Times New Roman" pitchFamily="18" charset="0"/>
              </a:rPr>
              <a:t> Figure S7</a:t>
            </a:r>
            <a:endParaRPr lang="es-E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upplementary Figure S8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696686"/>
            <a:ext cx="9144000" cy="478971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2428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 smtClean="0">
                <a:latin typeface="Times New Roman" pitchFamily="18" charset="0"/>
                <a:cs typeface="Times New Roman" pitchFamily="18" charset="0"/>
              </a:rPr>
              <a:t> Figure S8</a:t>
            </a:r>
            <a:endParaRPr lang="es-E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428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 smtClean="0">
                <a:latin typeface="Times New Roman" pitchFamily="18" charset="0"/>
                <a:cs typeface="Times New Roman" pitchFamily="18" charset="0"/>
              </a:rPr>
              <a:t> Figure S9</a:t>
            </a:r>
            <a:endParaRPr lang="es-E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 descr="ADC00.tif"/>
          <p:cNvPicPr>
            <a:picLocks noChangeAspect="1"/>
          </p:cNvPicPr>
          <p:nvPr/>
        </p:nvPicPr>
        <p:blipFill>
          <a:blip r:embed="rId2" cstate="print"/>
          <a:srcRect b="51112"/>
          <a:stretch>
            <a:fillRect/>
          </a:stretch>
        </p:blipFill>
        <p:spPr>
          <a:xfrm>
            <a:off x="0" y="609600"/>
            <a:ext cx="9144000" cy="3351312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</TotalTime>
  <Words>30</Words>
  <Application>Microsoft Office PowerPoint</Application>
  <PresentationFormat>On-screen Show (4:3)</PresentationFormat>
  <Paragraphs>10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nder</dc:creator>
  <cp:lastModifiedBy>Ander</cp:lastModifiedBy>
  <cp:revision>4</cp:revision>
  <dcterms:created xsi:type="dcterms:W3CDTF">2006-08-16T00:00:00Z</dcterms:created>
  <dcterms:modified xsi:type="dcterms:W3CDTF">2015-06-11T13:18:16Z</dcterms:modified>
</cp:coreProperties>
</file>